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8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633"/>
  </p:normalViewPr>
  <p:slideViewPr>
    <p:cSldViewPr snapToGrid="0" snapToObjects="1">
      <p:cViewPr varScale="1">
        <p:scale>
          <a:sx n="93" d="100"/>
          <a:sy n="93" d="100"/>
        </p:scale>
        <p:origin x="3408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358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78099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548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231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26755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0470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8189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1773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4948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616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574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1F148-BCAE-9F45-82B2-A576C9AD5751}" type="datetimeFigureOut">
              <a:rPr lang="en-US" smtClean="0"/>
              <a:t>2/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E33E62-5AA6-494C-8D62-EB50C7383D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65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89EAC093-580A-4C4F-8598-6AF3D67E42EA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748579" y="517099"/>
          <a:ext cx="5347421" cy="87164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228851">
                  <a:extLst>
                    <a:ext uri="{9D8B030D-6E8A-4147-A177-3AD203B41FA5}">
                      <a16:colId xmlns:a16="http://schemas.microsoft.com/office/drawing/2014/main" val="952885856"/>
                    </a:ext>
                  </a:extLst>
                </a:gridCol>
                <a:gridCol w="1708871">
                  <a:extLst>
                    <a:ext uri="{9D8B030D-6E8A-4147-A177-3AD203B41FA5}">
                      <a16:colId xmlns:a16="http://schemas.microsoft.com/office/drawing/2014/main" val="850890071"/>
                    </a:ext>
                  </a:extLst>
                </a:gridCol>
                <a:gridCol w="998441">
                  <a:extLst>
                    <a:ext uri="{9D8B030D-6E8A-4147-A177-3AD203B41FA5}">
                      <a16:colId xmlns:a16="http://schemas.microsoft.com/office/drawing/2014/main" val="1179232007"/>
                    </a:ext>
                  </a:extLst>
                </a:gridCol>
                <a:gridCol w="1411258">
                  <a:extLst>
                    <a:ext uri="{9D8B030D-6E8A-4147-A177-3AD203B41FA5}">
                      <a16:colId xmlns:a16="http://schemas.microsoft.com/office/drawing/2014/main" val="2150832595"/>
                    </a:ext>
                  </a:extLst>
                </a:gridCol>
              </a:tblGrid>
              <a:tr h="363185">
                <a:tc>
                  <a:txBody>
                    <a:bodyPr/>
                    <a:lstStyle/>
                    <a:p>
                      <a:r>
                        <a:rPr lang="en-US" sz="12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Gen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b="1" dirty="0"/>
                        <a:t>Assay number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0839880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BLK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2077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68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3047343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7831978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19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515420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8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283361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304161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S4A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54590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S4A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277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0249153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NFRSF1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9568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SF3R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273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721936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PTPRC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293577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FCGR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519988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512554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B8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182107_g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21R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60031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930406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8B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8116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CR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337324_g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81001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TSW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515599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XCL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477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148495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ZM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30445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3D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274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62106938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GZMB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2837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3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179194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5278039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18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99999901_s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3G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8095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189764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KLRB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189019_g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L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425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37575332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KLRD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9518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3810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3494142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KLRK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73603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SH2D1A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31699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9132627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CL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124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FOXP2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75162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0188789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209E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59980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BX2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50960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5297734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PRF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81251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2754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07545773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HSD11B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7618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IL2RA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340213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896102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24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79575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CR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963217_u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89867986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EOME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351984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PDCD1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128567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0323427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LAG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93071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TLA4 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86849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40058785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16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74091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TNFSF1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1906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3434981"/>
                  </a:ext>
                </a:extLst>
              </a:tr>
              <a:tr h="363185"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NOS2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0440502_m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i="1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CD27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1200" dirty="0">
                          <a:latin typeface="Arial" panose="020B0604020202020204" pitchFamily="34" charset="0"/>
                          <a:ea typeface="Calibri" panose="020F0502020204030204" pitchFamily="34" charset="0"/>
                        </a:rPr>
                        <a:t>Mm03048247_m1</a:t>
                      </a:r>
                      <a:endParaRPr lang="en-US" sz="12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13434308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2E9998D-2CFE-8C4E-ACF1-19F5AE0B383F}"/>
              </a:ext>
            </a:extLst>
          </p:cNvPr>
          <p:cNvSpPr txBox="1"/>
          <p:nvPr/>
        </p:nvSpPr>
        <p:spPr>
          <a:xfrm>
            <a:off x="0" y="0"/>
            <a:ext cx="1634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ry table 2</a:t>
            </a:r>
          </a:p>
        </p:txBody>
      </p:sp>
    </p:spTree>
    <p:extLst>
      <p:ext uri="{BB962C8B-B14F-4D97-AF65-F5344CB8AC3E}">
        <p14:creationId xmlns:p14="http://schemas.microsoft.com/office/powerpoint/2010/main" val="2101429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93</Words>
  <Application>Microsoft Macintosh PowerPoint</Application>
  <PresentationFormat>A4 Paper (210x297 mm)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8</cp:revision>
  <cp:lastPrinted>2024-02-01T12:16:11Z</cp:lastPrinted>
  <dcterms:created xsi:type="dcterms:W3CDTF">2024-02-01T12:09:59Z</dcterms:created>
  <dcterms:modified xsi:type="dcterms:W3CDTF">2024-02-01T12:16:39Z</dcterms:modified>
</cp:coreProperties>
</file>